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739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B42515BC-A166-42EE-B495-17D7B4A6BAD5}"/>
    <pc:docChg chg="delSld">
      <pc:chgData name="Norgard,Dr.,Bobby (DR CI+IM) BIP-US-R" userId="8fb42a27-e12b-430d-ab3b-20c232fde4c7" providerId="ADAL" clId="{B42515BC-A166-42EE-B495-17D7B4A6BAD5}" dt="2024-05-02T15:23:43.306" v="7" actId="47"/>
      <pc:docMkLst>
        <pc:docMk/>
      </pc:docMkLst>
      <pc:sldChg chg="del">
        <pc:chgData name="Norgard,Dr.,Bobby (DR CI+IM) BIP-US-R" userId="8fb42a27-e12b-430d-ab3b-20c232fde4c7" providerId="ADAL" clId="{B42515BC-A166-42EE-B495-17D7B4A6BAD5}" dt="2024-05-02T15:23:42.348" v="5" actId="47"/>
        <pc:sldMkLst>
          <pc:docMk/>
          <pc:sldMk cId="408838272" sldId="2147374672"/>
        </pc:sldMkLst>
      </pc:sldChg>
      <pc:sldChg chg="del">
        <pc:chgData name="Norgard,Dr.,Bobby (DR CI+IM) BIP-US-R" userId="8fb42a27-e12b-430d-ab3b-20c232fde4c7" providerId="ADAL" clId="{B42515BC-A166-42EE-B495-17D7B4A6BAD5}" dt="2024-05-02T15:23:41.402" v="2" actId="47"/>
        <pc:sldMkLst>
          <pc:docMk/>
          <pc:sldMk cId="3710560620" sldId="2147374714"/>
        </pc:sldMkLst>
      </pc:sldChg>
      <pc:sldChg chg="del">
        <pc:chgData name="Norgard,Dr.,Bobby (DR CI+IM) BIP-US-R" userId="8fb42a27-e12b-430d-ab3b-20c232fde4c7" providerId="ADAL" clId="{B42515BC-A166-42EE-B495-17D7B4A6BAD5}" dt="2024-05-02T15:23:39.440" v="0" actId="47"/>
        <pc:sldMkLst>
          <pc:docMk/>
          <pc:sldMk cId="457411378" sldId="2147374715"/>
        </pc:sldMkLst>
      </pc:sldChg>
      <pc:sldChg chg="del">
        <pc:chgData name="Norgard,Dr.,Bobby (DR CI+IM) BIP-US-R" userId="8fb42a27-e12b-430d-ab3b-20c232fde4c7" providerId="ADAL" clId="{B42515BC-A166-42EE-B495-17D7B4A6BAD5}" dt="2024-05-02T15:23:41.773" v="3" actId="47"/>
        <pc:sldMkLst>
          <pc:docMk/>
          <pc:sldMk cId="1104710727" sldId="2147374723"/>
        </pc:sldMkLst>
      </pc:sldChg>
      <pc:sldChg chg="del">
        <pc:chgData name="Norgard,Dr.,Bobby (DR CI+IM) BIP-US-R" userId="8fb42a27-e12b-430d-ab3b-20c232fde4c7" providerId="ADAL" clId="{B42515BC-A166-42EE-B495-17D7B4A6BAD5}" dt="2024-05-02T15:23:41.041" v="1" actId="47"/>
        <pc:sldMkLst>
          <pc:docMk/>
          <pc:sldMk cId="529728937" sldId="2147374740"/>
        </pc:sldMkLst>
      </pc:sldChg>
      <pc:sldChg chg="del">
        <pc:chgData name="Norgard,Dr.,Bobby (DR CI+IM) BIP-US-R" userId="8fb42a27-e12b-430d-ab3b-20c232fde4c7" providerId="ADAL" clId="{B42515BC-A166-42EE-B495-17D7B4A6BAD5}" dt="2024-05-02T15:23:42.020" v="4" actId="47"/>
        <pc:sldMkLst>
          <pc:docMk/>
          <pc:sldMk cId="1380050138" sldId="2147374741"/>
        </pc:sldMkLst>
      </pc:sldChg>
      <pc:sldChg chg="del">
        <pc:chgData name="Norgard,Dr.,Bobby (DR CI+IM) BIP-US-R" userId="8fb42a27-e12b-430d-ab3b-20c232fde4c7" providerId="ADAL" clId="{B42515BC-A166-42EE-B495-17D7B4A6BAD5}" dt="2024-05-02T15:23:43.306" v="7" actId="47"/>
        <pc:sldMkLst>
          <pc:docMk/>
          <pc:sldMk cId="2257143359" sldId="2147374742"/>
        </pc:sldMkLst>
      </pc:sldChg>
      <pc:sldChg chg="del">
        <pc:chgData name="Norgard,Dr.,Bobby (DR CI+IM) BIP-US-R" userId="8fb42a27-e12b-430d-ab3b-20c232fde4c7" providerId="ADAL" clId="{B42515BC-A166-42EE-B495-17D7B4A6BAD5}" dt="2024-05-02T15:23:42.715" v="6" actId="47"/>
        <pc:sldMkLst>
          <pc:docMk/>
          <pc:sldMk cId="1015601671" sldId="214737474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>
                <a:latin typeface="Segoe UI" panose="020B0502040204020203" pitchFamily="34" charset="0"/>
              </a:rPr>
              <a:t>Notes (Pratha)</a:t>
            </a:r>
          </a:p>
          <a:p>
            <a:r>
              <a:rPr lang="en-US" sz="1800">
                <a:latin typeface="Segoe UI" panose="020B0502040204020203" pitchFamily="34" charset="0"/>
              </a:rPr>
              <a:t>https://boehringer.sharepoint.com/:x:/s/z365kangteam/EUxsUwUzcd1Mq617o6OrkbEBMrJ07l-hIvTOKU0y7Xzx1A?email=pratha.budhani%40boehringer-ingelheim.com&amp;e=C7JcSC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04CE70-8047-4961-A4E1-7E2EBE4BCAF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0741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11" Type="http://schemas.openxmlformats.org/officeDocument/2006/relationships/image" Target="../media/image6.emf"/><Relationship Id="rId5" Type="http://schemas.openxmlformats.org/officeDocument/2006/relationships/oleObject" Target="../embeddings/oleObject2.bin"/><Relationship Id="rId10" Type="http://schemas.openxmlformats.org/officeDocument/2006/relationships/oleObject" Target="../embeddings/oleObject4.bin"/><Relationship Id="rId4" Type="http://schemas.openxmlformats.org/officeDocument/2006/relationships/image" Target="../media/image2.emf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E2A9B4C4-4755-4C11-82CD-D2C156F006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4459845"/>
              </p:ext>
            </p:extLst>
          </p:nvPr>
        </p:nvGraphicFramePr>
        <p:xfrm>
          <a:off x="1916113" y="1392064"/>
          <a:ext cx="2003425" cy="1516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250682" imgH="3216896" progId="Prism9.Document">
                  <p:embed/>
                </p:oleObj>
              </mc:Choice>
              <mc:Fallback>
                <p:oleObj name="Prism 9" r:id="rId3" imgW="4250682" imgH="3216896" progId="Prism9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E2A9B4C4-4755-4C11-82CD-D2C156F006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16113" y="1392064"/>
                        <a:ext cx="2003425" cy="1516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B5C748C-12A3-407E-9E61-B3B0B1595C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7593606"/>
              </p:ext>
            </p:extLst>
          </p:nvPr>
        </p:nvGraphicFramePr>
        <p:xfrm>
          <a:off x="3914632" y="1375925"/>
          <a:ext cx="1455738" cy="1344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035584" imgH="2803799" progId="Prism9.Document">
                  <p:embed/>
                </p:oleObj>
              </mc:Choice>
              <mc:Fallback>
                <p:oleObj name="Prism 9" r:id="rId5" imgW="3035584" imgH="2803799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B5C748C-12A3-407E-9E61-B3B0B1595C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14632" y="1375925"/>
                        <a:ext cx="1455738" cy="1344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8FB51A20-1037-4020-811E-DCA2CD4EEDC9}"/>
              </a:ext>
            </a:extLst>
          </p:cNvPr>
          <p:cNvSpPr txBox="1"/>
          <p:nvPr/>
        </p:nvSpPr>
        <p:spPr>
          <a:xfrm>
            <a:off x="3648634" y="1301919"/>
            <a:ext cx="196628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/>
              <a:t>B.</a:t>
            </a:r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892362DC-9D3B-41FC-9694-20F09E20BA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69106"/>
              </p:ext>
            </p:extLst>
          </p:nvPr>
        </p:nvGraphicFramePr>
        <p:xfrm>
          <a:off x="141288" y="1407939"/>
          <a:ext cx="2109787" cy="1370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4509619" imgH="2932014" progId="Prism9.Document">
                  <p:embed/>
                </p:oleObj>
              </mc:Choice>
              <mc:Fallback>
                <p:oleObj name="Prism 9" r:id="rId7" imgW="4509619" imgH="2932014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892362DC-9D3B-41FC-9694-20F09E20BA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1288" y="1407939"/>
                        <a:ext cx="2109787" cy="1370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228FA600-5799-3B9D-DE3A-1099B26A6AD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21236"/>
          <a:stretch/>
        </p:blipFill>
        <p:spPr>
          <a:xfrm>
            <a:off x="199642" y="3321387"/>
            <a:ext cx="4150143" cy="1073263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5E03B301-C85B-836F-8A73-FD608B599C47}"/>
              </a:ext>
            </a:extLst>
          </p:cNvPr>
          <p:cNvSpPr txBox="1"/>
          <p:nvPr/>
        </p:nvSpPr>
        <p:spPr>
          <a:xfrm>
            <a:off x="444500" y="4648299"/>
            <a:ext cx="552499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b="1"/>
              <a:t> </a:t>
            </a:r>
          </a:p>
          <a:p>
            <a:r>
              <a:rPr lang="en-US" sz="600" b="1"/>
              <a:t>CD45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15956A2F-963E-C623-4EE3-EF0D50A22429}"/>
              </a:ext>
            </a:extLst>
          </p:cNvPr>
          <p:cNvCxnSpPr>
            <a:cxnSpLocks/>
          </p:cNvCxnSpPr>
          <p:nvPr/>
        </p:nvCxnSpPr>
        <p:spPr>
          <a:xfrm>
            <a:off x="451078" y="4702803"/>
            <a:ext cx="282385" cy="342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6C95C7EC-A6E3-81F6-4B5F-EDBB9DB1FFCA}"/>
              </a:ext>
            </a:extLst>
          </p:cNvPr>
          <p:cNvCxnSpPr>
            <a:cxnSpLocks/>
          </p:cNvCxnSpPr>
          <p:nvPr/>
        </p:nvCxnSpPr>
        <p:spPr>
          <a:xfrm flipV="1">
            <a:off x="451078" y="4356749"/>
            <a:ext cx="0" cy="346054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B3B044F9-21C8-36C1-98E2-C24979672C11}"/>
              </a:ext>
            </a:extLst>
          </p:cNvPr>
          <p:cNvSpPr txBox="1"/>
          <p:nvPr/>
        </p:nvSpPr>
        <p:spPr>
          <a:xfrm>
            <a:off x="1491343" y="4636820"/>
            <a:ext cx="552499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b="1"/>
              <a:t> </a:t>
            </a:r>
          </a:p>
          <a:p>
            <a:r>
              <a:rPr lang="en-US" sz="600" b="1"/>
              <a:t>CD45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C99AB5E0-85BC-F28D-44AB-948309146071}"/>
              </a:ext>
            </a:extLst>
          </p:cNvPr>
          <p:cNvCxnSpPr>
            <a:cxnSpLocks/>
          </p:cNvCxnSpPr>
          <p:nvPr/>
        </p:nvCxnSpPr>
        <p:spPr>
          <a:xfrm flipV="1">
            <a:off x="1474216" y="4353012"/>
            <a:ext cx="0" cy="346054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A4B2CB20-6E0A-23E4-6241-CEB28ACF950E}"/>
              </a:ext>
            </a:extLst>
          </p:cNvPr>
          <p:cNvSpPr txBox="1"/>
          <p:nvPr/>
        </p:nvSpPr>
        <p:spPr>
          <a:xfrm rot="16200000">
            <a:off x="1057511" y="4451442"/>
            <a:ext cx="500462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b="1"/>
              <a:t>Lin</a:t>
            </a:r>
          </a:p>
          <a:p>
            <a:pPr algn="ctr"/>
            <a:r>
              <a:rPr lang="en-US" sz="500" b="1"/>
              <a:t>(CD11b NK1.1 TER119)</a:t>
            </a:r>
            <a:endParaRPr lang="en-US" sz="600" b="1"/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82F7ED09-3689-E26A-177C-90B4AB7A05C2}"/>
              </a:ext>
            </a:extLst>
          </p:cNvPr>
          <p:cNvCxnSpPr>
            <a:cxnSpLocks/>
          </p:cNvCxnSpPr>
          <p:nvPr/>
        </p:nvCxnSpPr>
        <p:spPr>
          <a:xfrm>
            <a:off x="1466393" y="4703957"/>
            <a:ext cx="282385" cy="342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E368B006-4FAA-ACFD-81FB-83CBD10689A1}"/>
              </a:ext>
            </a:extLst>
          </p:cNvPr>
          <p:cNvSpPr txBox="1"/>
          <p:nvPr/>
        </p:nvSpPr>
        <p:spPr>
          <a:xfrm>
            <a:off x="2452754" y="4644629"/>
            <a:ext cx="552499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b="1"/>
              <a:t> </a:t>
            </a:r>
          </a:p>
          <a:p>
            <a:r>
              <a:rPr lang="en-US" sz="600" b="1" err="1"/>
              <a:t>TCRb</a:t>
            </a:r>
            <a:r>
              <a:rPr lang="en-US" sz="600" b="1"/>
              <a:t> + CD3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88D3B375-25F4-C71A-FD5C-5F98F6525907}"/>
              </a:ext>
            </a:extLst>
          </p:cNvPr>
          <p:cNvCxnSpPr>
            <a:cxnSpLocks/>
          </p:cNvCxnSpPr>
          <p:nvPr/>
        </p:nvCxnSpPr>
        <p:spPr>
          <a:xfrm flipV="1">
            <a:off x="2492309" y="4353012"/>
            <a:ext cx="0" cy="346054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30A3609-749E-A8A5-F6DF-AD7E163E73BB}"/>
              </a:ext>
            </a:extLst>
          </p:cNvPr>
          <p:cNvSpPr txBox="1"/>
          <p:nvPr/>
        </p:nvSpPr>
        <p:spPr>
          <a:xfrm rot="16200000">
            <a:off x="2155350" y="4358194"/>
            <a:ext cx="500462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b="1"/>
              <a:t>CD4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B66AE2FE-DD60-79FA-3A03-AA16D86F0041}"/>
              </a:ext>
            </a:extLst>
          </p:cNvPr>
          <p:cNvCxnSpPr>
            <a:cxnSpLocks/>
          </p:cNvCxnSpPr>
          <p:nvPr/>
        </p:nvCxnSpPr>
        <p:spPr>
          <a:xfrm>
            <a:off x="2484486" y="4703957"/>
            <a:ext cx="282385" cy="342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2662CB45-BB83-C122-99E6-1AD9E5341557}"/>
              </a:ext>
            </a:extLst>
          </p:cNvPr>
          <p:cNvCxnSpPr>
            <a:cxnSpLocks/>
          </p:cNvCxnSpPr>
          <p:nvPr/>
        </p:nvCxnSpPr>
        <p:spPr>
          <a:xfrm flipV="1">
            <a:off x="3503860" y="4346770"/>
            <a:ext cx="0" cy="346054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6EB62BAC-5943-F606-D3D5-3F7C60AEEB1F}"/>
              </a:ext>
            </a:extLst>
          </p:cNvPr>
          <p:cNvCxnSpPr>
            <a:cxnSpLocks/>
          </p:cNvCxnSpPr>
          <p:nvPr/>
        </p:nvCxnSpPr>
        <p:spPr>
          <a:xfrm>
            <a:off x="3496037" y="4691365"/>
            <a:ext cx="282385" cy="342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E1F9C58-1268-7900-1521-6BB3305E3E01}"/>
              </a:ext>
            </a:extLst>
          </p:cNvPr>
          <p:cNvSpPr txBox="1"/>
          <p:nvPr/>
        </p:nvSpPr>
        <p:spPr>
          <a:xfrm rot="16200000">
            <a:off x="3136903" y="4349316"/>
            <a:ext cx="552499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b="1"/>
              <a:t>CD8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064252A-FB33-74F4-870D-55A147EE56F7}"/>
              </a:ext>
            </a:extLst>
          </p:cNvPr>
          <p:cNvSpPr txBox="1"/>
          <p:nvPr/>
        </p:nvSpPr>
        <p:spPr>
          <a:xfrm rot="16200000">
            <a:off x="101036" y="4310582"/>
            <a:ext cx="552499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b="1"/>
              <a:t>YFP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7F99395-76A1-504B-149B-A24AFFB2195C}"/>
              </a:ext>
            </a:extLst>
          </p:cNvPr>
          <p:cNvSpPr txBox="1"/>
          <p:nvPr/>
        </p:nvSpPr>
        <p:spPr>
          <a:xfrm>
            <a:off x="3447683" y="4644629"/>
            <a:ext cx="552499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600" b="1"/>
              <a:t> </a:t>
            </a:r>
          </a:p>
          <a:p>
            <a:r>
              <a:rPr lang="en-US" sz="600" b="1"/>
              <a:t>     CD4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E7261CD-193B-CE6C-09A2-FA3D82AF06B7}"/>
              </a:ext>
            </a:extLst>
          </p:cNvPr>
          <p:cNvSpPr txBox="1"/>
          <p:nvPr/>
        </p:nvSpPr>
        <p:spPr>
          <a:xfrm>
            <a:off x="915034" y="3390523"/>
            <a:ext cx="267702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700" b="1">
                <a:solidFill>
                  <a:srgbClr val="FF0000"/>
                </a:solidFill>
              </a:rPr>
              <a:t>CD45+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7FC98E9-04D3-E4BB-2F3F-B3F7053FAE85}"/>
              </a:ext>
            </a:extLst>
          </p:cNvPr>
          <p:cNvSpPr txBox="1"/>
          <p:nvPr/>
        </p:nvSpPr>
        <p:spPr>
          <a:xfrm>
            <a:off x="1755379" y="3913555"/>
            <a:ext cx="167628" cy="10772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700" b="1">
                <a:solidFill>
                  <a:srgbClr val="FF0000"/>
                </a:solidFill>
              </a:rPr>
              <a:t>Lin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B28FAE9-2B48-D6CF-C3D7-335AC06A10F4}"/>
              </a:ext>
            </a:extLst>
          </p:cNvPr>
          <p:cNvSpPr txBox="1"/>
          <p:nvPr/>
        </p:nvSpPr>
        <p:spPr>
          <a:xfrm>
            <a:off x="3071661" y="3656082"/>
            <a:ext cx="22281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700" b="1">
                <a:solidFill>
                  <a:srgbClr val="FF0000"/>
                </a:solidFill>
              </a:rPr>
              <a:t>CD3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F9EBA94-C2C8-8605-9D25-ECA6A0B3C4C8}"/>
              </a:ext>
            </a:extLst>
          </p:cNvPr>
          <p:cNvSpPr txBox="1"/>
          <p:nvPr/>
        </p:nvSpPr>
        <p:spPr>
          <a:xfrm>
            <a:off x="3933261" y="3518560"/>
            <a:ext cx="222818" cy="10772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700" b="1">
                <a:solidFill>
                  <a:srgbClr val="FF0000"/>
                </a:solidFill>
              </a:rPr>
              <a:t>CD8T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0C0C4DAA-3DD4-8950-47CD-E87677309BD6}"/>
              </a:ext>
            </a:extLst>
          </p:cNvPr>
          <p:cNvCxnSpPr>
            <a:cxnSpLocks/>
          </p:cNvCxnSpPr>
          <p:nvPr/>
        </p:nvCxnSpPr>
        <p:spPr>
          <a:xfrm>
            <a:off x="1182736" y="4104286"/>
            <a:ext cx="249073" cy="0"/>
          </a:xfrm>
          <a:prstGeom prst="straightConnector1">
            <a:avLst/>
          </a:prstGeom>
          <a:ln w="28575">
            <a:solidFill>
              <a:srgbClr val="CC3333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ED710A95-3755-1F4C-B55C-22D32861C593}"/>
              </a:ext>
            </a:extLst>
          </p:cNvPr>
          <p:cNvCxnSpPr>
            <a:cxnSpLocks/>
          </p:cNvCxnSpPr>
          <p:nvPr/>
        </p:nvCxnSpPr>
        <p:spPr>
          <a:xfrm>
            <a:off x="2160584" y="4104286"/>
            <a:ext cx="249073" cy="0"/>
          </a:xfrm>
          <a:prstGeom prst="straightConnector1">
            <a:avLst/>
          </a:prstGeom>
          <a:ln w="28575">
            <a:solidFill>
              <a:srgbClr val="CC3333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F3D3020C-F9AB-CACD-2F77-784866CCFCBF}"/>
              </a:ext>
            </a:extLst>
          </p:cNvPr>
          <p:cNvCxnSpPr>
            <a:cxnSpLocks/>
          </p:cNvCxnSpPr>
          <p:nvPr/>
        </p:nvCxnSpPr>
        <p:spPr>
          <a:xfrm>
            <a:off x="3082293" y="3970127"/>
            <a:ext cx="343552" cy="0"/>
          </a:xfrm>
          <a:prstGeom prst="straightConnector1">
            <a:avLst/>
          </a:prstGeom>
          <a:ln w="28575">
            <a:solidFill>
              <a:srgbClr val="CC3333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B704FB41-FD23-4CE5-FF39-8AC84B8391AE}"/>
              </a:ext>
            </a:extLst>
          </p:cNvPr>
          <p:cNvSpPr txBox="1"/>
          <p:nvPr/>
        </p:nvSpPr>
        <p:spPr>
          <a:xfrm>
            <a:off x="67250" y="4948459"/>
            <a:ext cx="264783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/>
              <a:t>D.</a:t>
            </a:r>
          </a:p>
        </p:txBody>
      </p:sp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C682585B-AAAF-976F-8A1C-45BB3ED267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7917321"/>
              </p:ext>
            </p:extLst>
          </p:nvPr>
        </p:nvGraphicFramePr>
        <p:xfrm>
          <a:off x="5142902" y="1377771"/>
          <a:ext cx="1406525" cy="1344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942309" imgH="2803799" progId="Prism9.Document">
                  <p:embed/>
                </p:oleObj>
              </mc:Choice>
              <mc:Fallback>
                <p:oleObj name="Prism 9" r:id="rId10" imgW="2942309" imgH="2803799" progId="Prism9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C682585B-AAAF-976F-8A1C-45BB3ED267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142902" y="1377771"/>
                        <a:ext cx="1406525" cy="1344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" name="TextBox 55">
            <a:extLst>
              <a:ext uri="{FF2B5EF4-FFF2-40B4-BE49-F238E27FC236}">
                <a16:creationId xmlns:a16="http://schemas.microsoft.com/office/drawing/2014/main" id="{DE6A4CDC-1FEF-B153-7C0D-9F88EE542AC4}"/>
              </a:ext>
            </a:extLst>
          </p:cNvPr>
          <p:cNvSpPr txBox="1"/>
          <p:nvPr/>
        </p:nvSpPr>
        <p:spPr>
          <a:xfrm>
            <a:off x="67250" y="1251739"/>
            <a:ext cx="196628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/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B6E28DD-AE6D-EED5-501C-1A688D3C8219}"/>
              </a:ext>
            </a:extLst>
          </p:cNvPr>
          <p:cNvSpPr txBox="1"/>
          <p:nvPr/>
        </p:nvSpPr>
        <p:spPr>
          <a:xfrm>
            <a:off x="67250" y="2907867"/>
            <a:ext cx="264783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/>
              <a:t>C.</a:t>
            </a:r>
          </a:p>
        </p:txBody>
      </p:sp>
      <p:pic>
        <p:nvPicPr>
          <p:cNvPr id="12" name="Content Placeholder 3" descr="A picture containing indoor, dark&#10;&#10;Description automatically generated">
            <a:extLst>
              <a:ext uri="{FF2B5EF4-FFF2-40B4-BE49-F238E27FC236}">
                <a16:creationId xmlns:a16="http://schemas.microsoft.com/office/drawing/2014/main" id="{952E394B-3D2B-E506-184B-3EF76C94D6D1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554" y="4586447"/>
            <a:ext cx="3438538" cy="24064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CD22985-779F-0180-9EB6-B1AB19E40BE1}"/>
              </a:ext>
            </a:extLst>
          </p:cNvPr>
          <p:cNvSpPr txBox="1"/>
          <p:nvPr/>
        </p:nvSpPr>
        <p:spPr>
          <a:xfrm>
            <a:off x="1167514" y="3134840"/>
            <a:ext cx="2328523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400"/>
              <a:t>Representative gating strateg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E537A06-F7D8-3DC2-9419-FF81705F0832}"/>
              </a:ext>
            </a:extLst>
          </p:cNvPr>
          <p:cNvSpPr txBox="1"/>
          <p:nvPr/>
        </p:nvSpPr>
        <p:spPr>
          <a:xfrm>
            <a:off x="420130" y="7228703"/>
            <a:ext cx="583238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ividual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mor volume (mm</a:t>
            </a: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curves in TC5 clone after no treatment (n=7) or treatment with SOS1i+MEKi (n=7) for 18 days BID. Arrows indicate days of treatment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ar graph showing composition of CD8+ T cells in CD45+ cells in TC4 clone (n=3, left) or TC5 clone (n=5, right) after 10 days of treatment with vehicle or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S1i+MEKi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Student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.test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rformed (*=0.05)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flow cytometry gating strategy for CD8+ T cells in TC5 clone after 8 days of treatment.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ematic of bi-lateral concurrent tumor inoculation model.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itle 2">
            <a:extLst>
              <a:ext uri="{FF2B5EF4-FFF2-40B4-BE49-F238E27FC236}">
                <a16:creationId xmlns:a16="http://schemas.microsoft.com/office/drawing/2014/main" id="{50779A64-734B-4EFF-7F7B-740A37EF67EC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657975" cy="3079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24342376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</TotalTime>
  <Words>205</Words>
  <Application>Microsoft Office PowerPoint</Application>
  <PresentationFormat>Letter Paper (8.5x11 in)</PresentationFormat>
  <Paragraphs>2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3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